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  <p:sldId id="257" r:id="rId6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5DA0972-9DFB-435F-8163-FEBC1F0F3021}" v="7" dt="2025-03-19T15:33:58.59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2429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ox, Elizabeth" userId="c7619ef2-11a7-4c4f-9237-3743934715e8" providerId="ADAL" clId="{E5DA0972-9DFB-435F-8163-FEBC1F0F3021}"/>
    <pc:docChg chg="undo custSel addSld modSld">
      <pc:chgData name="Fox, Elizabeth" userId="c7619ef2-11a7-4c4f-9237-3743934715e8" providerId="ADAL" clId="{E5DA0972-9DFB-435F-8163-FEBC1F0F3021}" dt="2025-03-19T15:34:45.120" v="159" actId="14100"/>
      <pc:docMkLst>
        <pc:docMk/>
      </pc:docMkLst>
      <pc:sldChg chg="addSp delSp modSp mod">
        <pc:chgData name="Fox, Elizabeth" userId="c7619ef2-11a7-4c4f-9237-3743934715e8" providerId="ADAL" clId="{E5DA0972-9DFB-435F-8163-FEBC1F0F3021}" dt="2025-03-19T15:34:45.120" v="159" actId="14100"/>
        <pc:sldMkLst>
          <pc:docMk/>
          <pc:sldMk cId="3007879694" sldId="256"/>
        </pc:sldMkLst>
        <pc:spChg chg="add mod">
          <ac:chgData name="Fox, Elizabeth" userId="c7619ef2-11a7-4c4f-9237-3743934715e8" providerId="ADAL" clId="{E5DA0972-9DFB-435F-8163-FEBC1F0F3021}" dt="2025-03-18T14:38:10.883" v="10" actId="20577"/>
          <ac:spMkLst>
            <pc:docMk/>
            <pc:sldMk cId="3007879694" sldId="256"/>
            <ac:spMk id="2" creationId="{566BF526-5270-7E17-394E-FCB6E15FA30A}"/>
          </ac:spMkLst>
        </pc:spChg>
        <pc:spChg chg="add del mod">
          <ac:chgData name="Fox, Elizabeth" userId="c7619ef2-11a7-4c4f-9237-3743934715e8" providerId="ADAL" clId="{E5DA0972-9DFB-435F-8163-FEBC1F0F3021}" dt="2025-03-19T15:33:46.613" v="148" actId="478"/>
          <ac:spMkLst>
            <pc:docMk/>
            <pc:sldMk cId="3007879694" sldId="256"/>
            <ac:spMk id="6" creationId="{1891B5F3-59B2-0122-2D06-D84F0FB62652}"/>
          </ac:spMkLst>
        </pc:spChg>
        <pc:spChg chg="mod">
          <ac:chgData name="Fox, Elizabeth" userId="c7619ef2-11a7-4c4f-9237-3743934715e8" providerId="ADAL" clId="{E5DA0972-9DFB-435F-8163-FEBC1F0F3021}" dt="2025-03-18T19:35:24.509" v="55" actId="20577"/>
          <ac:spMkLst>
            <pc:docMk/>
            <pc:sldMk cId="3007879694" sldId="256"/>
            <ac:spMk id="10" creationId="{F0DAAD06-8276-40F6-A26E-DCD751AF63D7}"/>
          </ac:spMkLst>
        </pc:spChg>
        <pc:spChg chg="add mod">
          <ac:chgData name="Fox, Elizabeth" userId="c7619ef2-11a7-4c4f-9237-3743934715e8" providerId="ADAL" clId="{E5DA0972-9DFB-435F-8163-FEBC1F0F3021}" dt="2025-03-19T15:34:45.120" v="159" actId="14100"/>
          <ac:spMkLst>
            <pc:docMk/>
            <pc:sldMk cId="3007879694" sldId="256"/>
            <ac:spMk id="12" creationId="{8DFA155D-324A-6AF1-D349-965C407DFE06}"/>
          </ac:spMkLst>
        </pc:spChg>
        <pc:spChg chg="mod">
          <ac:chgData name="Fox, Elizabeth" userId="c7619ef2-11a7-4c4f-9237-3743934715e8" providerId="ADAL" clId="{E5DA0972-9DFB-435F-8163-FEBC1F0F3021}" dt="2025-03-19T15:10:54.425" v="60" actId="1076"/>
          <ac:spMkLst>
            <pc:docMk/>
            <pc:sldMk cId="3007879694" sldId="256"/>
            <ac:spMk id="26" creationId="{131C2486-AF18-4779-BE07-CEEAB52D8CCD}"/>
          </ac:spMkLst>
        </pc:spChg>
        <pc:spChg chg="mod">
          <ac:chgData name="Fox, Elizabeth" userId="c7619ef2-11a7-4c4f-9237-3743934715e8" providerId="ADAL" clId="{E5DA0972-9DFB-435F-8163-FEBC1F0F3021}" dt="2025-03-19T15:33:34.470" v="145" actId="14100"/>
          <ac:spMkLst>
            <pc:docMk/>
            <pc:sldMk cId="3007879694" sldId="256"/>
            <ac:spMk id="37" creationId="{DBB97BB8-A6E7-49AF-8574-8E91C3A9C874}"/>
          </ac:spMkLst>
        </pc:spChg>
        <pc:spChg chg="mod">
          <ac:chgData name="Fox, Elizabeth" userId="c7619ef2-11a7-4c4f-9237-3743934715e8" providerId="ADAL" clId="{E5DA0972-9DFB-435F-8163-FEBC1F0F3021}" dt="2025-03-19T15:34:32.388" v="158" actId="20577"/>
          <ac:spMkLst>
            <pc:docMk/>
            <pc:sldMk cId="3007879694" sldId="256"/>
            <ac:spMk id="134" creationId="{F1C6DF61-B485-4BD3-9F7A-2A75BA971966}"/>
          </ac:spMkLst>
        </pc:spChg>
        <pc:spChg chg="mod">
          <ac:chgData name="Fox, Elizabeth" userId="c7619ef2-11a7-4c4f-9237-3743934715e8" providerId="ADAL" clId="{E5DA0972-9DFB-435F-8163-FEBC1F0F3021}" dt="2025-03-19T15:34:21.894" v="154" actId="1076"/>
          <ac:spMkLst>
            <pc:docMk/>
            <pc:sldMk cId="3007879694" sldId="256"/>
            <ac:spMk id="137" creationId="{1E10791E-0645-7A8D-3CD0-A66775CB4CDE}"/>
          </ac:spMkLst>
        </pc:spChg>
        <pc:spChg chg="mod">
          <ac:chgData name="Fox, Elizabeth" userId="c7619ef2-11a7-4c4f-9237-3743934715e8" providerId="ADAL" clId="{E5DA0972-9DFB-435F-8163-FEBC1F0F3021}" dt="2025-03-19T15:23:29.869" v="71" actId="1076"/>
          <ac:spMkLst>
            <pc:docMk/>
            <pc:sldMk cId="3007879694" sldId="256"/>
            <ac:spMk id="164" creationId="{5CC554D3-F1A4-B9F5-270F-5E1BFC66F060}"/>
          </ac:spMkLst>
        </pc:spChg>
        <pc:cxnChg chg="add del mod">
          <ac:chgData name="Fox, Elizabeth" userId="c7619ef2-11a7-4c4f-9237-3743934715e8" providerId="ADAL" clId="{E5DA0972-9DFB-435F-8163-FEBC1F0F3021}" dt="2025-03-19T15:34:28.729" v="155" actId="478"/>
          <ac:cxnSpMkLst>
            <pc:docMk/>
            <pc:sldMk cId="3007879694" sldId="256"/>
            <ac:cxnSpMk id="11" creationId="{3829AC36-685B-82B1-21F6-71C9AF875268}"/>
          </ac:cxnSpMkLst>
        </pc:cxnChg>
        <pc:cxnChg chg="add mod">
          <ac:chgData name="Fox, Elizabeth" userId="c7619ef2-11a7-4c4f-9237-3743934715e8" providerId="ADAL" clId="{E5DA0972-9DFB-435F-8163-FEBC1F0F3021}" dt="2025-03-19T15:34:06.514" v="152" actId="1076"/>
          <ac:cxnSpMkLst>
            <pc:docMk/>
            <pc:sldMk cId="3007879694" sldId="256"/>
            <ac:cxnSpMk id="14" creationId="{468C2AB9-A90D-1AA7-8273-191F5E1CE7FA}"/>
          </ac:cxnSpMkLst>
        </pc:cxnChg>
        <pc:cxnChg chg="mod">
          <ac:chgData name="Fox, Elizabeth" userId="c7619ef2-11a7-4c4f-9237-3743934715e8" providerId="ADAL" clId="{E5DA0972-9DFB-435F-8163-FEBC1F0F3021}" dt="2025-03-19T15:23:58.239" v="78" actId="1076"/>
          <ac:cxnSpMkLst>
            <pc:docMk/>
            <pc:sldMk cId="3007879694" sldId="256"/>
            <ac:cxnSpMk id="54" creationId="{644148E5-C0E5-AACF-D0B8-9417FE1912D8}"/>
          </ac:cxnSpMkLst>
        </pc:cxnChg>
        <pc:cxnChg chg="mod">
          <ac:chgData name="Fox, Elizabeth" userId="c7619ef2-11a7-4c4f-9237-3743934715e8" providerId="ADAL" clId="{E5DA0972-9DFB-435F-8163-FEBC1F0F3021}" dt="2025-03-19T15:31:33.397" v="82" actId="14100"/>
          <ac:cxnSpMkLst>
            <pc:docMk/>
            <pc:sldMk cId="3007879694" sldId="256"/>
            <ac:cxnSpMk id="189" creationId="{A63882B4-E4DC-77BC-07CD-FAFB45D971CA}"/>
          </ac:cxnSpMkLst>
        </pc:cxnChg>
        <pc:cxnChg chg="mod">
          <ac:chgData name="Fox, Elizabeth" userId="c7619ef2-11a7-4c4f-9237-3743934715e8" providerId="ADAL" clId="{E5DA0972-9DFB-435F-8163-FEBC1F0F3021}" dt="2025-03-19T15:34:21.894" v="154" actId="1076"/>
          <ac:cxnSpMkLst>
            <pc:docMk/>
            <pc:sldMk cId="3007879694" sldId="256"/>
            <ac:cxnSpMk id="191" creationId="{BCECF2AA-07A7-645E-8E66-21E83619D04B}"/>
          </ac:cxnSpMkLst>
        </pc:cxnChg>
      </pc:sldChg>
      <pc:sldChg chg="addSp delSp modSp add mod">
        <pc:chgData name="Fox, Elizabeth" userId="c7619ef2-11a7-4c4f-9237-3743934715e8" providerId="ADAL" clId="{E5DA0972-9DFB-435F-8163-FEBC1F0F3021}" dt="2025-03-19T15:17:50.074" v="66" actId="1036"/>
        <pc:sldMkLst>
          <pc:docMk/>
          <pc:sldMk cId="1286145911" sldId="257"/>
        </pc:sldMkLst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4" creationId="{533AB7EE-28B5-6049-A803-3DEAC0E3BE85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5" creationId="{51699A68-24B1-5651-BAED-894E09C86007}"/>
          </ac:spMkLst>
        </pc:spChg>
        <pc:spChg chg="add mod">
          <ac:chgData name="Fox, Elizabeth" userId="c7619ef2-11a7-4c4f-9237-3743934715e8" providerId="ADAL" clId="{E5DA0972-9DFB-435F-8163-FEBC1F0F3021}" dt="2025-03-18T19:28:50.938" v="20"/>
          <ac:spMkLst>
            <pc:docMk/>
            <pc:sldMk cId="1286145911" sldId="257"/>
            <ac:spMk id="6" creationId="{5D8DA1E6-6021-3CD4-739C-D2F321266A1A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7" creationId="{9AC57011-5297-B432-85C9-3C50B8623F80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8" creationId="{E072B163-C343-F479-11B3-20D7A967B200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9" creationId="{6A5361CD-9341-0C29-4CAA-B89362DDF75A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10" creationId="{F0DAAD06-8276-40F6-A26E-DCD751AF63D7}"/>
          </ac:spMkLst>
        </pc:spChg>
        <pc:spChg chg="add mod">
          <ac:chgData name="Fox, Elizabeth" userId="c7619ef2-11a7-4c4f-9237-3743934715e8" providerId="ADAL" clId="{E5DA0972-9DFB-435F-8163-FEBC1F0F3021}" dt="2025-03-18T19:28:50.938" v="20"/>
          <ac:spMkLst>
            <pc:docMk/>
            <pc:sldMk cId="1286145911" sldId="257"/>
            <ac:spMk id="12" creationId="{2A259E9B-68E7-E256-8295-0DB24C9A7FDC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13" creationId="{D77E9862-BD50-433F-BC70-5A1A27A21E01}"/>
          </ac:spMkLst>
        </pc:spChg>
        <pc:spChg chg="add mod">
          <ac:chgData name="Fox, Elizabeth" userId="c7619ef2-11a7-4c4f-9237-3743934715e8" providerId="ADAL" clId="{E5DA0972-9DFB-435F-8163-FEBC1F0F3021}" dt="2025-03-18T19:28:50.938" v="20"/>
          <ac:spMkLst>
            <pc:docMk/>
            <pc:sldMk cId="1286145911" sldId="257"/>
            <ac:spMk id="14" creationId="{B7F12BCF-AD15-C4B2-A30B-20225B38C6C1}"/>
          </ac:spMkLst>
        </pc:spChg>
        <pc:spChg chg="add mod">
          <ac:chgData name="Fox, Elizabeth" userId="c7619ef2-11a7-4c4f-9237-3743934715e8" providerId="ADAL" clId="{E5DA0972-9DFB-435F-8163-FEBC1F0F3021}" dt="2025-03-18T19:28:50.938" v="20"/>
          <ac:spMkLst>
            <pc:docMk/>
            <pc:sldMk cId="1286145911" sldId="257"/>
            <ac:spMk id="15" creationId="{5CEBEAE3-C3CF-C9E6-5C8A-0F62C7C1D8F8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16" creationId="{349DDB1D-41D3-4CF1-85CE-CC0ED200B018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17" creationId="{5DAC98D3-325F-4FBA-BDB5-21A30CE494DA}"/>
          </ac:spMkLst>
        </pc:spChg>
        <pc:spChg chg="add mod">
          <ac:chgData name="Fox, Elizabeth" userId="c7619ef2-11a7-4c4f-9237-3743934715e8" providerId="ADAL" clId="{E5DA0972-9DFB-435F-8163-FEBC1F0F3021}" dt="2025-03-18T19:28:50.938" v="20"/>
          <ac:spMkLst>
            <pc:docMk/>
            <pc:sldMk cId="1286145911" sldId="257"/>
            <ac:spMk id="18" creationId="{FD9B77BB-2326-5537-62C8-C4B9DED55854}"/>
          </ac:spMkLst>
        </pc:spChg>
        <pc:spChg chg="add mod">
          <ac:chgData name="Fox, Elizabeth" userId="c7619ef2-11a7-4c4f-9237-3743934715e8" providerId="ADAL" clId="{E5DA0972-9DFB-435F-8163-FEBC1F0F3021}" dt="2025-03-18T19:33:20.998" v="27"/>
          <ac:spMkLst>
            <pc:docMk/>
            <pc:sldMk cId="1286145911" sldId="257"/>
            <ac:spMk id="22" creationId="{1C34972A-D3AD-E327-CCBA-9660C3727F01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23" creationId="{F00342B0-F987-FC6A-29DE-6F881E6B1623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25" creationId="{7CD389C0-F022-4EB4-A21D-D21FD76EEC25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26" creationId="{131C2486-AF18-4779-BE07-CEEAB52D8CCD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27" creationId="{05FF95FA-99E2-4686-BED5-3ED60C0A5193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28" creationId="{77CFF669-0751-45C8-9079-C0DA62F0D433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29" creationId="{F73C9F69-2379-492B-9C79-1ACA3D7A8465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30" creationId="{BF2A4347-05ED-4596-AB59-FDA7AE84A45E}"/>
          </ac:spMkLst>
        </pc:spChg>
        <pc:spChg chg="add mod">
          <ac:chgData name="Fox, Elizabeth" userId="c7619ef2-11a7-4c4f-9237-3743934715e8" providerId="ADAL" clId="{E5DA0972-9DFB-435F-8163-FEBC1F0F3021}" dt="2025-03-18T19:33:20.998" v="27"/>
          <ac:spMkLst>
            <pc:docMk/>
            <pc:sldMk cId="1286145911" sldId="257"/>
            <ac:spMk id="31" creationId="{29321839-5ECA-6143-2BEA-C40FDE4BFE5E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33" creationId="{9BF96916-7180-4FC6-9122-60E62D54B8AF}"/>
          </ac:spMkLst>
        </pc:spChg>
        <pc:spChg chg="add mod">
          <ac:chgData name="Fox, Elizabeth" userId="c7619ef2-11a7-4c4f-9237-3743934715e8" providerId="ADAL" clId="{E5DA0972-9DFB-435F-8163-FEBC1F0F3021}" dt="2025-03-18T19:33:20.998" v="27"/>
          <ac:spMkLst>
            <pc:docMk/>
            <pc:sldMk cId="1286145911" sldId="257"/>
            <ac:spMk id="34" creationId="{79741804-D1B7-8D90-9ACE-4AB8A6425B9C}"/>
          </ac:spMkLst>
        </pc:spChg>
        <pc:spChg chg="add mod">
          <ac:chgData name="Fox, Elizabeth" userId="c7619ef2-11a7-4c4f-9237-3743934715e8" providerId="ADAL" clId="{E5DA0972-9DFB-435F-8163-FEBC1F0F3021}" dt="2025-03-18T19:33:20.998" v="27"/>
          <ac:spMkLst>
            <pc:docMk/>
            <pc:sldMk cId="1286145911" sldId="257"/>
            <ac:spMk id="35" creationId="{29D32690-A0D9-B05B-6514-A24417D2AFB3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37" creationId="{DBB97BB8-A6E7-49AF-8574-8E91C3A9C874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38" creationId="{1545E607-9759-4D15-BD41-F54C6F126183}"/>
          </ac:spMkLst>
        </pc:spChg>
        <pc:spChg chg="add mod">
          <ac:chgData name="Fox, Elizabeth" userId="c7619ef2-11a7-4c4f-9237-3743934715e8" providerId="ADAL" clId="{E5DA0972-9DFB-435F-8163-FEBC1F0F3021}" dt="2025-03-18T19:33:31.485" v="30"/>
          <ac:spMkLst>
            <pc:docMk/>
            <pc:sldMk cId="1286145911" sldId="257"/>
            <ac:spMk id="40" creationId="{E6BC68F2-9456-67A6-E0B7-88EF8821624B}"/>
          </ac:spMkLst>
        </pc:spChg>
        <pc:spChg chg="add mod">
          <ac:chgData name="Fox, Elizabeth" userId="c7619ef2-11a7-4c4f-9237-3743934715e8" providerId="ADAL" clId="{E5DA0972-9DFB-435F-8163-FEBC1F0F3021}" dt="2025-03-18T19:33:31.485" v="30"/>
          <ac:spMkLst>
            <pc:docMk/>
            <pc:sldMk cId="1286145911" sldId="257"/>
            <ac:spMk id="43" creationId="{E4D9A462-21D7-28D6-0B35-79F0416A9EF9}"/>
          </ac:spMkLst>
        </pc:spChg>
        <pc:spChg chg="add mod">
          <ac:chgData name="Fox, Elizabeth" userId="c7619ef2-11a7-4c4f-9237-3743934715e8" providerId="ADAL" clId="{E5DA0972-9DFB-435F-8163-FEBC1F0F3021}" dt="2025-03-18T19:33:31.485" v="30"/>
          <ac:spMkLst>
            <pc:docMk/>
            <pc:sldMk cId="1286145911" sldId="257"/>
            <ac:spMk id="44" creationId="{64B16B61-6B3B-DBA0-FB72-BC50C6134D3E}"/>
          </ac:spMkLst>
        </pc:spChg>
        <pc:spChg chg="add mod">
          <ac:chgData name="Fox, Elizabeth" userId="c7619ef2-11a7-4c4f-9237-3743934715e8" providerId="ADAL" clId="{E5DA0972-9DFB-435F-8163-FEBC1F0F3021}" dt="2025-03-18T19:33:31.485" v="30"/>
          <ac:spMkLst>
            <pc:docMk/>
            <pc:sldMk cId="1286145911" sldId="257"/>
            <ac:spMk id="45" creationId="{B90C7C38-D865-5085-6E5E-73ECB3261583}"/>
          </ac:spMkLst>
        </pc:spChg>
        <pc:spChg chg="add mod">
          <ac:chgData name="Fox, Elizabeth" userId="c7619ef2-11a7-4c4f-9237-3743934715e8" providerId="ADAL" clId="{E5DA0972-9DFB-435F-8163-FEBC1F0F3021}" dt="2025-03-18T19:34:46.790" v="35" actId="1076"/>
          <ac:spMkLst>
            <pc:docMk/>
            <pc:sldMk cId="1286145911" sldId="257"/>
            <ac:spMk id="51" creationId="{4D54160F-852C-6A4B-ED2B-C29AFF46AE97}"/>
          </ac:spMkLst>
        </pc:spChg>
        <pc:spChg chg="add mod">
          <ac:chgData name="Fox, Elizabeth" userId="c7619ef2-11a7-4c4f-9237-3743934715e8" providerId="ADAL" clId="{E5DA0972-9DFB-435F-8163-FEBC1F0F3021}" dt="2025-03-18T19:34:46.790" v="35" actId="1076"/>
          <ac:spMkLst>
            <pc:docMk/>
            <pc:sldMk cId="1286145911" sldId="257"/>
            <ac:spMk id="55" creationId="{C4D6F9AD-6574-2B40-76CB-7E7BEB1AC837}"/>
          </ac:spMkLst>
        </pc:spChg>
        <pc:spChg chg="add mod">
          <ac:chgData name="Fox, Elizabeth" userId="c7619ef2-11a7-4c4f-9237-3743934715e8" providerId="ADAL" clId="{E5DA0972-9DFB-435F-8163-FEBC1F0F3021}" dt="2025-03-18T19:34:46.790" v="35" actId="1076"/>
          <ac:spMkLst>
            <pc:docMk/>
            <pc:sldMk cId="1286145911" sldId="257"/>
            <ac:spMk id="56" creationId="{0292F8EC-02F0-61A2-2C5C-13DDF1F867AC}"/>
          </ac:spMkLst>
        </pc:spChg>
        <pc:spChg chg="add mod">
          <ac:chgData name="Fox, Elizabeth" userId="c7619ef2-11a7-4c4f-9237-3743934715e8" providerId="ADAL" clId="{E5DA0972-9DFB-435F-8163-FEBC1F0F3021}" dt="2025-03-19T15:17:50.074" v="66" actId="1036"/>
          <ac:spMkLst>
            <pc:docMk/>
            <pc:sldMk cId="1286145911" sldId="257"/>
            <ac:spMk id="58" creationId="{C41B943D-216D-57B3-46ED-519B4AA03D0A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84" creationId="{563AAB04-8909-4260-8FE0-76856FC3242C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118" creationId="{6D7C3738-F73E-44D7-B4E4-35858D3A48C7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122" creationId="{C9336000-355A-4061-94FF-F10AEB1D2D85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124" creationId="{674448F4-E74C-4EC3-9527-12197CF0E881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128" creationId="{D30DFE23-69C3-47EE-AF80-7E5A8DC45E20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133" creationId="{4D00D8A1-3B0C-41F3-A00D-E6227C0EEFD6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134" creationId="{F1C6DF61-B485-4BD3-9F7A-2A75BA971966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137" creationId="{1E10791E-0645-7A8D-3CD0-A66775CB4CDE}"/>
          </ac:spMkLst>
        </pc:spChg>
        <pc:spChg chg="mod">
          <ac:chgData name="Fox, Elizabeth" userId="c7619ef2-11a7-4c4f-9237-3743934715e8" providerId="ADAL" clId="{E5DA0972-9DFB-435F-8163-FEBC1F0F3021}" dt="2025-03-18T19:35:01.934" v="43" actId="113"/>
          <ac:spMkLst>
            <pc:docMk/>
            <pc:sldMk cId="1286145911" sldId="257"/>
            <ac:spMk id="163" creationId="{F519353C-ACB2-009D-71DD-DA957017DA1D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164" creationId="{5CC554D3-F1A4-B9F5-270F-5E1BFC66F060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167" creationId="{877705AE-1A4C-4EC4-EC05-BB62135314F2}"/>
          </ac:spMkLst>
        </pc:spChg>
        <pc:spChg chg="add del">
          <ac:chgData name="Fox, Elizabeth" userId="c7619ef2-11a7-4c4f-9237-3743934715e8" providerId="ADAL" clId="{E5DA0972-9DFB-435F-8163-FEBC1F0F3021}" dt="2025-03-18T19:29:31.747" v="23" actId="478"/>
          <ac:spMkLst>
            <pc:docMk/>
            <pc:sldMk cId="1286145911" sldId="257"/>
            <ac:spMk id="169" creationId="{A89AB435-1ECE-C589-CE4B-8C89BDDC4852}"/>
          </ac:spMkLst>
        </pc:spChg>
        <pc:graphicFrameChg chg="add mod">
          <ac:chgData name="Fox, Elizabeth" userId="c7619ef2-11a7-4c4f-9237-3743934715e8" providerId="ADAL" clId="{E5DA0972-9DFB-435F-8163-FEBC1F0F3021}" dt="2025-03-18T19:28:41.698" v="13"/>
          <ac:graphicFrameMkLst>
            <pc:docMk/>
            <pc:sldMk cId="1286145911" sldId="257"/>
            <ac:graphicFrameMk id="3" creationId="{57FBFAC4-ECCB-BDAF-F30D-9FDFF8C02426}"/>
          </ac:graphicFrameMkLst>
        </pc:graphicFrameChg>
        <pc:graphicFrameChg chg="add mod">
          <ac:chgData name="Fox, Elizabeth" userId="c7619ef2-11a7-4c4f-9237-3743934715e8" providerId="ADAL" clId="{E5DA0972-9DFB-435F-8163-FEBC1F0F3021}" dt="2025-03-18T19:33:17.434" v="24"/>
          <ac:graphicFrameMkLst>
            <pc:docMk/>
            <pc:sldMk cId="1286145911" sldId="257"/>
            <ac:graphicFrameMk id="20" creationId="{9BA1F1BB-6D18-F09E-9010-25575312B89B}"/>
          </ac:graphicFrameMkLst>
        </pc:graphicFrameChg>
        <pc:graphicFrameChg chg="add mod">
          <ac:chgData name="Fox, Elizabeth" userId="c7619ef2-11a7-4c4f-9237-3743934715e8" providerId="ADAL" clId="{E5DA0972-9DFB-435F-8163-FEBC1F0F3021}" dt="2025-03-18T19:33:28.039" v="29"/>
          <ac:graphicFrameMkLst>
            <pc:docMk/>
            <pc:sldMk cId="1286145911" sldId="257"/>
            <ac:graphicFrameMk id="39" creationId="{7C430979-CB91-4300-8264-355CF691B8C0}"/>
          </ac:graphicFrameMkLst>
        </pc:graphicFrameChg>
        <pc:graphicFrameChg chg="add mod">
          <ac:chgData name="Fox, Elizabeth" userId="c7619ef2-11a7-4c4f-9237-3743934715e8" providerId="ADAL" clId="{E5DA0972-9DFB-435F-8163-FEBC1F0F3021}" dt="2025-03-18T19:34:46.790" v="35" actId="1076"/>
          <ac:graphicFrameMkLst>
            <pc:docMk/>
            <pc:sldMk cId="1286145911" sldId="257"/>
            <ac:graphicFrameMk id="49" creationId="{92574808-9FEA-7B0C-99AD-35689BA2247E}"/>
          </ac:graphicFrameMkLst>
        </pc:graphicFrameChg>
        <pc:picChg chg="add">
          <ac:chgData name="Fox, Elizabeth" userId="c7619ef2-11a7-4c4f-9237-3743934715e8" providerId="ADAL" clId="{E5DA0972-9DFB-435F-8163-FEBC1F0F3021}" dt="2025-03-18T19:28:51.099" v="21"/>
          <ac:picMkLst>
            <pc:docMk/>
            <pc:sldMk cId="1286145911" sldId="257"/>
            <ac:picMk id="19" creationId="{E6E4862D-EBE0-0DEA-96F9-86E8D18EFA07}"/>
          </ac:picMkLst>
        </pc:picChg>
        <pc:picChg chg="add">
          <ac:chgData name="Fox, Elizabeth" userId="c7619ef2-11a7-4c4f-9237-3743934715e8" providerId="ADAL" clId="{E5DA0972-9DFB-435F-8163-FEBC1F0F3021}" dt="2025-03-18T19:33:21.133" v="28"/>
          <ac:picMkLst>
            <pc:docMk/>
            <pc:sldMk cId="1286145911" sldId="257"/>
            <ac:picMk id="36" creationId="{5CE79565-05E9-C440-1955-39B34CFD7C99}"/>
          </ac:picMkLst>
        </pc:picChg>
        <pc:picChg chg="add">
          <ac:chgData name="Fox, Elizabeth" userId="c7619ef2-11a7-4c4f-9237-3743934715e8" providerId="ADAL" clId="{E5DA0972-9DFB-435F-8163-FEBC1F0F3021}" dt="2025-03-18T19:33:31.624" v="31"/>
          <ac:picMkLst>
            <pc:docMk/>
            <pc:sldMk cId="1286145911" sldId="257"/>
            <ac:picMk id="47" creationId="{56816FA8-388D-5C78-8586-7954449EB754}"/>
          </ac:picMkLst>
        </pc:picChg>
        <pc:cxnChg chg="add mod">
          <ac:chgData name="Fox, Elizabeth" userId="c7619ef2-11a7-4c4f-9237-3743934715e8" providerId="ADAL" clId="{E5DA0972-9DFB-435F-8163-FEBC1F0F3021}" dt="2025-03-18T19:28:50.938" v="20"/>
          <ac:cxnSpMkLst>
            <pc:docMk/>
            <pc:sldMk cId="1286145911" sldId="257"/>
            <ac:cxnSpMk id="11" creationId="{64DAF71E-61F8-4F44-2830-04934BF86B9F}"/>
          </ac:cxnSpMkLst>
        </pc:cxnChg>
        <pc:cxnChg chg="add del mod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21" creationId="{BE56C444-CBBB-197E-FFE4-566E9AF3977D}"/>
          </ac:cxnSpMkLst>
        </pc:cxnChg>
        <pc:cxnChg chg="add mod">
          <ac:chgData name="Fox, Elizabeth" userId="c7619ef2-11a7-4c4f-9237-3743934715e8" providerId="ADAL" clId="{E5DA0972-9DFB-435F-8163-FEBC1F0F3021}" dt="2025-03-18T19:33:20.998" v="27"/>
          <ac:cxnSpMkLst>
            <pc:docMk/>
            <pc:sldMk cId="1286145911" sldId="257"/>
            <ac:cxnSpMk id="24" creationId="{38A3A16D-803C-91B5-8053-15A12892C811}"/>
          </ac:cxnSpMkLst>
        </pc:cxnChg>
        <pc:cxnChg chg="add del mod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32" creationId="{0A2E38FC-8F3D-D06A-3ADE-CEAEAFC8F515}"/>
          </ac:cxnSpMkLst>
        </pc:cxnChg>
        <pc:cxnChg chg="add del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41" creationId="{CF0D5C5C-57E4-4352-9D4D-087BCAE623FD}"/>
          </ac:cxnSpMkLst>
        </pc:cxnChg>
        <pc:cxnChg chg="add mod">
          <ac:chgData name="Fox, Elizabeth" userId="c7619ef2-11a7-4c4f-9237-3743934715e8" providerId="ADAL" clId="{E5DA0972-9DFB-435F-8163-FEBC1F0F3021}" dt="2025-03-18T19:33:31.485" v="30"/>
          <ac:cxnSpMkLst>
            <pc:docMk/>
            <pc:sldMk cId="1286145911" sldId="257"/>
            <ac:cxnSpMk id="42" creationId="{FE589072-3F51-1CAB-701A-4DBF1C970E25}"/>
          </ac:cxnSpMkLst>
        </pc:cxnChg>
        <pc:cxnChg chg="add del mod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46" creationId="{8BB99208-8573-A7BA-A354-9E8CC7E6766F}"/>
          </ac:cxnSpMkLst>
        </pc:cxnChg>
        <pc:cxnChg chg="add del mod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48" creationId="{EEE0D6D5-77B7-4AE6-AAE7-E9B70B383443}"/>
          </ac:cxnSpMkLst>
        </pc:cxnChg>
        <pc:cxnChg chg="add del mod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50" creationId="{975D471F-E5D6-4159-A51A-BCC219CA6988}"/>
          </ac:cxnSpMkLst>
        </pc:cxnChg>
        <pc:cxnChg chg="add del mod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52" creationId="{6917EB4A-BB93-A338-8DC1-B2A54D33D073}"/>
          </ac:cxnSpMkLst>
        </pc:cxnChg>
        <pc:cxnChg chg="add mod">
          <ac:chgData name="Fox, Elizabeth" userId="c7619ef2-11a7-4c4f-9237-3743934715e8" providerId="ADAL" clId="{E5DA0972-9DFB-435F-8163-FEBC1F0F3021}" dt="2025-03-18T19:34:46.790" v="35" actId="1076"/>
          <ac:cxnSpMkLst>
            <pc:docMk/>
            <pc:sldMk cId="1286145911" sldId="257"/>
            <ac:cxnSpMk id="53" creationId="{1307070F-5E23-D418-7ADD-FDC9A71C1A8D}"/>
          </ac:cxnSpMkLst>
        </pc:cxnChg>
        <pc:cxnChg chg="add del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54" creationId="{644148E5-C0E5-AACF-D0B8-9417FE1912D8}"/>
          </ac:cxnSpMkLst>
        </pc:cxnChg>
        <pc:cxnChg chg="add del mod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57" creationId="{E18B6460-DB1A-414A-A484-632141826535}"/>
          </ac:cxnSpMkLst>
        </pc:cxnChg>
        <pc:cxnChg chg="add del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59" creationId="{0CB0B4DD-8EB5-4009-9B9E-22343EC5C0C3}"/>
          </ac:cxnSpMkLst>
        </pc:cxnChg>
        <pc:cxnChg chg="add del mod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65" creationId="{BCEB3DDB-B8AA-4C3A-BBD7-E93392E29C99}"/>
          </ac:cxnSpMkLst>
        </pc:cxnChg>
        <pc:cxnChg chg="add del mod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85" creationId="{21C15718-3CBE-47D6-C501-184593EFC664}"/>
          </ac:cxnSpMkLst>
        </pc:cxnChg>
        <pc:cxnChg chg="add del mod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86" creationId="{9255C2D1-7042-4C00-AE8A-0319075AFDF3}"/>
          </ac:cxnSpMkLst>
        </pc:cxnChg>
        <pc:cxnChg chg="add del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126" creationId="{BE48E71D-82C3-4D19-AB5C-9506F6B0070C}"/>
          </ac:cxnSpMkLst>
        </pc:cxnChg>
        <pc:cxnChg chg="add del mod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170" creationId="{95561660-A653-9D89-93EB-13EEE4E57CAD}"/>
          </ac:cxnSpMkLst>
        </pc:cxnChg>
        <pc:cxnChg chg="add del mod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189" creationId="{A63882B4-E4DC-77BC-07CD-FAFB45D971CA}"/>
          </ac:cxnSpMkLst>
        </pc:cxnChg>
        <pc:cxnChg chg="add del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191" creationId="{BCECF2AA-07A7-645E-8E66-21E83619D04B}"/>
          </ac:cxnSpMkLst>
        </pc:cxnChg>
        <pc:cxnChg chg="add del">
          <ac:chgData name="Fox, Elizabeth" userId="c7619ef2-11a7-4c4f-9237-3743934715e8" providerId="ADAL" clId="{E5DA0972-9DFB-435F-8163-FEBC1F0F3021}" dt="2025-03-18T19:29:31.747" v="23" actId="478"/>
          <ac:cxnSpMkLst>
            <pc:docMk/>
            <pc:sldMk cId="1286145911" sldId="257"/>
            <ac:cxnSpMk id="195" creationId="{F2A447CF-FD87-ABCA-079A-9B73787BF8C1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5371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495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83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237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053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331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102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644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5597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361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249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262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26" name="Straight Arrow Connector 125">
            <a:extLst>
              <a:ext uri="{FF2B5EF4-FFF2-40B4-BE49-F238E27FC236}">
                <a16:creationId xmlns:a16="http://schemas.microsoft.com/office/drawing/2014/main" id="{BE48E71D-82C3-4D19-AB5C-9506F6B0070C}"/>
              </a:ext>
            </a:extLst>
          </p:cNvPr>
          <p:cNvCxnSpPr>
            <a:cxnSpLocks/>
          </p:cNvCxnSpPr>
          <p:nvPr/>
        </p:nvCxnSpPr>
        <p:spPr>
          <a:xfrm>
            <a:off x="979618" y="6376559"/>
            <a:ext cx="0" cy="69679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Flowchart: Data 9">
            <a:extLst>
              <a:ext uri="{FF2B5EF4-FFF2-40B4-BE49-F238E27FC236}">
                <a16:creationId xmlns:a16="http://schemas.microsoft.com/office/drawing/2014/main" id="{F0DAAD06-8276-40F6-A26E-DCD751AF63D7}"/>
              </a:ext>
            </a:extLst>
          </p:cNvPr>
          <p:cNvSpPr/>
          <p:nvPr/>
        </p:nvSpPr>
        <p:spPr>
          <a:xfrm>
            <a:off x="415709" y="1630788"/>
            <a:ext cx="1541417" cy="850789"/>
          </a:xfrm>
          <a:prstGeom prst="flowChartInputOutpu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1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Observe and Identify Occurrence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D77E9862-BD50-433F-BC70-5A1A27A21E01}"/>
              </a:ext>
            </a:extLst>
          </p:cNvPr>
          <p:cNvSpPr/>
          <p:nvPr/>
        </p:nvSpPr>
        <p:spPr>
          <a:xfrm>
            <a:off x="2330264" y="1630788"/>
            <a:ext cx="1227909" cy="850789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2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Alert Supervisor</a:t>
            </a:r>
          </a:p>
        </p:txBody>
      </p:sp>
      <p:sp>
        <p:nvSpPr>
          <p:cNvPr id="16" name="Flowchart: Decision 15">
            <a:extLst>
              <a:ext uri="{FF2B5EF4-FFF2-40B4-BE49-F238E27FC236}">
                <a16:creationId xmlns:a16="http://schemas.microsoft.com/office/drawing/2014/main" id="{349DDB1D-41D3-4CF1-85CE-CC0ED200B018}"/>
              </a:ext>
            </a:extLst>
          </p:cNvPr>
          <p:cNvSpPr/>
          <p:nvPr/>
        </p:nvSpPr>
        <p:spPr>
          <a:xfrm>
            <a:off x="6455149" y="1782354"/>
            <a:ext cx="548640" cy="548640"/>
          </a:xfrm>
          <a:prstGeom prst="flowChartDecision">
            <a:avLst/>
          </a:prstGeom>
          <a:solidFill>
            <a:srgbClr val="A6F0F8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7CD389C0-F022-4EB4-A21D-D21FD76EEC25}"/>
              </a:ext>
            </a:extLst>
          </p:cNvPr>
          <p:cNvSpPr/>
          <p:nvPr/>
        </p:nvSpPr>
        <p:spPr>
          <a:xfrm>
            <a:off x="3931309" y="3446688"/>
            <a:ext cx="1227909" cy="850789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4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Investigation Lead &amp; Team Assigned</a:t>
            </a:r>
          </a:p>
        </p:txBody>
      </p:sp>
      <p:sp>
        <p:nvSpPr>
          <p:cNvPr id="26" name="Parallelogram 25">
            <a:extLst>
              <a:ext uri="{FF2B5EF4-FFF2-40B4-BE49-F238E27FC236}">
                <a16:creationId xmlns:a16="http://schemas.microsoft.com/office/drawing/2014/main" id="{131C2486-AF18-4779-BE07-CEEAB52D8CCD}"/>
              </a:ext>
            </a:extLst>
          </p:cNvPr>
          <p:cNvSpPr/>
          <p:nvPr/>
        </p:nvSpPr>
        <p:spPr>
          <a:xfrm>
            <a:off x="2092359" y="3443553"/>
            <a:ext cx="1425749" cy="847663"/>
          </a:xfrm>
          <a:prstGeom prst="parallelogram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5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Gather Occurrence Information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05FF95FA-99E2-4686-BED5-3ED60C0A5193}"/>
              </a:ext>
            </a:extLst>
          </p:cNvPr>
          <p:cNvSpPr/>
          <p:nvPr/>
        </p:nvSpPr>
        <p:spPr>
          <a:xfrm>
            <a:off x="430072" y="3443554"/>
            <a:ext cx="1227909" cy="847663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6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Organize and Review Occurrence Information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7CFF669-0751-45C8-9079-C0DA62F0D433}"/>
              </a:ext>
            </a:extLst>
          </p:cNvPr>
          <p:cNvSpPr/>
          <p:nvPr/>
        </p:nvSpPr>
        <p:spPr>
          <a:xfrm>
            <a:off x="2180690" y="5665649"/>
            <a:ext cx="1227909" cy="850788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7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Execute CAPA Process</a:t>
            </a:r>
          </a:p>
        </p:txBody>
      </p:sp>
      <p:sp>
        <p:nvSpPr>
          <p:cNvPr id="29" name="Flowchart: Decision 28">
            <a:extLst>
              <a:ext uri="{FF2B5EF4-FFF2-40B4-BE49-F238E27FC236}">
                <a16:creationId xmlns:a16="http://schemas.microsoft.com/office/drawing/2014/main" id="{F73C9F69-2379-492B-9C79-1ACA3D7A8465}"/>
              </a:ext>
            </a:extLst>
          </p:cNvPr>
          <p:cNvSpPr/>
          <p:nvPr/>
        </p:nvSpPr>
        <p:spPr>
          <a:xfrm>
            <a:off x="718527" y="5827919"/>
            <a:ext cx="548640" cy="548640"/>
          </a:xfrm>
          <a:prstGeom prst="flowChartDecision">
            <a:avLst/>
          </a:prstGeom>
          <a:solidFill>
            <a:srgbClr val="A6F0F8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Flowchart: Document 32">
            <a:extLst>
              <a:ext uri="{FF2B5EF4-FFF2-40B4-BE49-F238E27FC236}">
                <a16:creationId xmlns:a16="http://schemas.microsoft.com/office/drawing/2014/main" id="{9BF96916-7180-4FC6-9122-60E62D54B8AF}"/>
              </a:ext>
            </a:extLst>
          </p:cNvPr>
          <p:cNvSpPr/>
          <p:nvPr/>
        </p:nvSpPr>
        <p:spPr>
          <a:xfrm>
            <a:off x="392085" y="7084380"/>
            <a:ext cx="1228408" cy="978948"/>
          </a:xfrm>
          <a:prstGeom prst="flowChartDocumen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91440" rtlCol="0" anchor="t" anchorCtr="0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Develop Occurrence Investigation Report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BB97BB8-A6E7-49AF-8574-8E91C3A9C874}"/>
              </a:ext>
            </a:extLst>
          </p:cNvPr>
          <p:cNvSpPr/>
          <p:nvPr/>
        </p:nvSpPr>
        <p:spPr>
          <a:xfrm>
            <a:off x="5929101" y="6821940"/>
            <a:ext cx="1410789" cy="764457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10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Apply Corrective Action(s), as Necessary</a:t>
            </a:r>
          </a:p>
        </p:txBody>
      </p:sp>
      <p:sp>
        <p:nvSpPr>
          <p:cNvPr id="38" name="Flowchart: Terminator 37">
            <a:extLst>
              <a:ext uri="{FF2B5EF4-FFF2-40B4-BE49-F238E27FC236}">
                <a16:creationId xmlns:a16="http://schemas.microsoft.com/office/drawing/2014/main" id="{1545E607-9759-4D15-BD41-F54C6F126183}"/>
              </a:ext>
            </a:extLst>
          </p:cNvPr>
          <p:cNvSpPr/>
          <p:nvPr/>
        </p:nvSpPr>
        <p:spPr>
          <a:xfrm>
            <a:off x="1003272" y="477950"/>
            <a:ext cx="528883" cy="180934"/>
          </a:xfrm>
          <a:prstGeom prst="flowChartTerminator">
            <a:avLst/>
          </a:prstGeom>
          <a:solidFill>
            <a:schemeClr val="accent6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CF0D5C5C-57E4-4352-9D4D-087BCAE623FD}"/>
              </a:ext>
            </a:extLst>
          </p:cNvPr>
          <p:cNvCxnSpPr>
            <a:cxnSpLocks/>
          </p:cNvCxnSpPr>
          <p:nvPr/>
        </p:nvCxnSpPr>
        <p:spPr>
          <a:xfrm>
            <a:off x="1243485" y="933320"/>
            <a:ext cx="0" cy="67632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EE0D6D5-77B7-4AE6-AAE7-E9B70B383443}"/>
              </a:ext>
            </a:extLst>
          </p:cNvPr>
          <p:cNvCxnSpPr>
            <a:cxnSpLocks/>
            <a:stCxn id="10" idx="5"/>
            <a:endCxn id="13" idx="1"/>
          </p:cNvCxnSpPr>
          <p:nvPr/>
        </p:nvCxnSpPr>
        <p:spPr>
          <a:xfrm>
            <a:off x="1802984" y="2056183"/>
            <a:ext cx="52728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975D471F-E5D6-4159-A51A-BCC219CA6988}"/>
              </a:ext>
            </a:extLst>
          </p:cNvPr>
          <p:cNvCxnSpPr>
            <a:cxnSpLocks/>
            <a:endCxn id="16" idx="1"/>
          </p:cNvCxnSpPr>
          <p:nvPr/>
        </p:nvCxnSpPr>
        <p:spPr>
          <a:xfrm>
            <a:off x="5002211" y="2056285"/>
            <a:ext cx="1452938" cy="38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E18B6460-DB1A-414A-A484-632141826535}"/>
              </a:ext>
            </a:extLst>
          </p:cNvPr>
          <p:cNvCxnSpPr>
            <a:cxnSpLocks/>
            <a:endCxn id="27" idx="3"/>
          </p:cNvCxnSpPr>
          <p:nvPr/>
        </p:nvCxnSpPr>
        <p:spPr>
          <a:xfrm flipH="1">
            <a:off x="1657981" y="3867386"/>
            <a:ext cx="52270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0CB0B4DD-8EB5-4009-9B9E-22343EC5C0C3}"/>
              </a:ext>
            </a:extLst>
          </p:cNvPr>
          <p:cNvCxnSpPr>
            <a:cxnSpLocks/>
          </p:cNvCxnSpPr>
          <p:nvPr/>
        </p:nvCxnSpPr>
        <p:spPr>
          <a:xfrm>
            <a:off x="1003272" y="4320969"/>
            <a:ext cx="0" cy="14824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BCEB3DDB-B8AA-4C3A-BBD7-E93392E29C99}"/>
              </a:ext>
            </a:extLst>
          </p:cNvPr>
          <p:cNvCxnSpPr>
            <a:cxnSpLocks/>
            <a:stCxn id="29" idx="3"/>
            <a:endCxn id="28" idx="1"/>
          </p:cNvCxnSpPr>
          <p:nvPr/>
        </p:nvCxnSpPr>
        <p:spPr>
          <a:xfrm flipV="1">
            <a:off x="1267167" y="6091043"/>
            <a:ext cx="913523" cy="1119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Flowchart: Document 83">
            <a:extLst>
              <a:ext uri="{FF2B5EF4-FFF2-40B4-BE49-F238E27FC236}">
                <a16:creationId xmlns:a16="http://schemas.microsoft.com/office/drawing/2014/main" id="{563AAB04-8909-4260-8FE0-76856FC3242C}"/>
              </a:ext>
            </a:extLst>
          </p:cNvPr>
          <p:cNvSpPr/>
          <p:nvPr/>
        </p:nvSpPr>
        <p:spPr>
          <a:xfrm>
            <a:off x="6125317" y="474137"/>
            <a:ext cx="1208301" cy="632939"/>
          </a:xfrm>
          <a:prstGeom prst="flowChartDocumen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Develop Incident Report</a:t>
            </a:r>
          </a:p>
        </p:txBody>
      </p: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9255C2D1-7042-4C00-AE8A-0319075AFDF3}"/>
              </a:ext>
            </a:extLst>
          </p:cNvPr>
          <p:cNvCxnSpPr>
            <a:cxnSpLocks/>
            <a:endCxn id="84" idx="2"/>
          </p:cNvCxnSpPr>
          <p:nvPr/>
        </p:nvCxnSpPr>
        <p:spPr>
          <a:xfrm flipH="1" flipV="1">
            <a:off x="6729468" y="1065232"/>
            <a:ext cx="1059" cy="7171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6D7C3738-F73E-44D7-B4E4-35858D3A48C7}"/>
              </a:ext>
            </a:extLst>
          </p:cNvPr>
          <p:cNvSpPr txBox="1"/>
          <p:nvPr/>
        </p:nvSpPr>
        <p:spPr>
          <a:xfrm>
            <a:off x="6465027" y="1348051"/>
            <a:ext cx="529054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0" bIns="0" rtlCol="0">
            <a:spAutoFit/>
          </a:bodyPr>
          <a:lstStyle/>
          <a:p>
            <a:pPr algn="ctr"/>
            <a:r>
              <a:rPr lang="en-US" sz="1100" dirty="0"/>
              <a:t>Yes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674448F4-E74C-4EC3-9527-12197CF0E881}"/>
              </a:ext>
            </a:extLst>
          </p:cNvPr>
          <p:cNvSpPr txBox="1"/>
          <p:nvPr/>
        </p:nvSpPr>
        <p:spPr>
          <a:xfrm>
            <a:off x="728320" y="6564456"/>
            <a:ext cx="529054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No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D30DFE23-69C3-47EE-AF80-7E5A8DC45E20}"/>
              </a:ext>
            </a:extLst>
          </p:cNvPr>
          <p:cNvSpPr txBox="1"/>
          <p:nvPr/>
        </p:nvSpPr>
        <p:spPr>
          <a:xfrm>
            <a:off x="1588681" y="5961949"/>
            <a:ext cx="259786" cy="261610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ctr"/>
            <a:r>
              <a:rPr lang="en-US" sz="1100" dirty="0"/>
              <a:t>Yes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F1C6DF61-B485-4BD3-9F7A-2A75BA971966}"/>
              </a:ext>
            </a:extLst>
          </p:cNvPr>
          <p:cNvSpPr txBox="1"/>
          <p:nvPr/>
        </p:nvSpPr>
        <p:spPr>
          <a:xfrm>
            <a:off x="6358155" y="9584263"/>
            <a:ext cx="5288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End</a:t>
            </a:r>
          </a:p>
        </p:txBody>
      </p:sp>
      <p:sp>
        <p:nvSpPr>
          <p:cNvPr id="4" name="Flowchart: Decision 3">
            <a:extLst>
              <a:ext uri="{FF2B5EF4-FFF2-40B4-BE49-F238E27FC236}">
                <a16:creationId xmlns:a16="http://schemas.microsoft.com/office/drawing/2014/main" id="{533AB7EE-28B5-6049-A803-3DEAC0E3BE85}"/>
              </a:ext>
            </a:extLst>
          </p:cNvPr>
          <p:cNvSpPr/>
          <p:nvPr/>
        </p:nvSpPr>
        <p:spPr>
          <a:xfrm>
            <a:off x="6455149" y="3591626"/>
            <a:ext cx="548640" cy="548640"/>
          </a:xfrm>
          <a:prstGeom prst="flowChartDecision">
            <a:avLst/>
          </a:prstGeom>
          <a:solidFill>
            <a:srgbClr val="A6F0F8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1699A68-24B1-5651-BAED-894E09C86007}"/>
              </a:ext>
            </a:extLst>
          </p:cNvPr>
          <p:cNvSpPr/>
          <p:nvPr/>
        </p:nvSpPr>
        <p:spPr>
          <a:xfrm>
            <a:off x="6127800" y="4675335"/>
            <a:ext cx="1203338" cy="445055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Go to Step 9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DAC98D3-325F-4FBA-BDB5-21A30CE494DA}"/>
              </a:ext>
            </a:extLst>
          </p:cNvPr>
          <p:cNvSpPr txBox="1"/>
          <p:nvPr/>
        </p:nvSpPr>
        <p:spPr>
          <a:xfrm>
            <a:off x="5371449" y="1538690"/>
            <a:ext cx="783842" cy="1015663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b="1" i="1" dirty="0"/>
              <a:t>Is it an Occupational Health Incident or Event of Concern?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6917EB4A-BB93-A338-8DC1-B2A54D33D073}"/>
              </a:ext>
            </a:extLst>
          </p:cNvPr>
          <p:cNvCxnSpPr>
            <a:cxnSpLocks/>
            <a:endCxn id="4" idx="0"/>
          </p:cNvCxnSpPr>
          <p:nvPr/>
        </p:nvCxnSpPr>
        <p:spPr>
          <a:xfrm>
            <a:off x="6729469" y="2318405"/>
            <a:ext cx="0" cy="127322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id="{C9336000-355A-4061-94FF-F10AEB1D2D85}"/>
              </a:ext>
            </a:extLst>
          </p:cNvPr>
          <p:cNvSpPr txBox="1"/>
          <p:nvPr/>
        </p:nvSpPr>
        <p:spPr>
          <a:xfrm>
            <a:off x="6540974" y="2555008"/>
            <a:ext cx="401682" cy="169277"/>
          </a:xfrm>
          <a:prstGeom prst="rect">
            <a:avLst/>
          </a:prstGeom>
          <a:solidFill>
            <a:schemeClr val="bg1"/>
          </a:solidFill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1100" dirty="0"/>
              <a:t>No</a:t>
            </a:r>
          </a:p>
        </p:txBody>
      </p: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21C15718-3CBE-47D6-C501-184593EFC664}"/>
              </a:ext>
            </a:extLst>
          </p:cNvPr>
          <p:cNvCxnSpPr>
            <a:cxnSpLocks/>
            <a:stCxn id="4" idx="2"/>
            <a:endCxn id="5" idx="0"/>
          </p:cNvCxnSpPr>
          <p:nvPr/>
        </p:nvCxnSpPr>
        <p:spPr>
          <a:xfrm>
            <a:off x="6729469" y="4140266"/>
            <a:ext cx="0" cy="53506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7" name="Flowchart: Terminator 136">
            <a:extLst>
              <a:ext uri="{FF2B5EF4-FFF2-40B4-BE49-F238E27FC236}">
                <a16:creationId xmlns:a16="http://schemas.microsoft.com/office/drawing/2014/main" id="{1E10791E-0645-7A8D-3CD0-A66775CB4CDE}"/>
              </a:ext>
            </a:extLst>
          </p:cNvPr>
          <p:cNvSpPr/>
          <p:nvPr/>
        </p:nvSpPr>
        <p:spPr>
          <a:xfrm>
            <a:off x="6358155" y="9383155"/>
            <a:ext cx="528883" cy="201108"/>
          </a:xfrm>
          <a:prstGeom prst="flowChartTerminator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4D00D8A1-3B0C-41F3-A00D-E6227C0EEFD6}"/>
              </a:ext>
            </a:extLst>
          </p:cNvPr>
          <p:cNvSpPr txBox="1"/>
          <p:nvPr/>
        </p:nvSpPr>
        <p:spPr>
          <a:xfrm>
            <a:off x="1003272" y="671710"/>
            <a:ext cx="52888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Start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F519353C-ACB2-009D-71DD-DA957017DA1D}"/>
              </a:ext>
            </a:extLst>
          </p:cNvPr>
          <p:cNvSpPr txBox="1"/>
          <p:nvPr/>
        </p:nvSpPr>
        <p:spPr>
          <a:xfrm>
            <a:off x="384082" y="9488095"/>
            <a:ext cx="38862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ysClr val="windowText" lastClr="000000"/>
                </a:solidFill>
              </a:rPr>
              <a:t>*CAPA = Corrective and Preventive Action</a:t>
            </a:r>
            <a:endParaRPr lang="en-US" sz="1200" dirty="0"/>
          </a:p>
        </p:txBody>
      </p:sp>
      <p:sp>
        <p:nvSpPr>
          <p:cNvPr id="164" name="Parallelogram 163">
            <a:extLst>
              <a:ext uri="{FF2B5EF4-FFF2-40B4-BE49-F238E27FC236}">
                <a16:creationId xmlns:a16="http://schemas.microsoft.com/office/drawing/2014/main" id="{5CC554D3-F1A4-B9F5-270F-5E1BFC66F060}"/>
              </a:ext>
            </a:extLst>
          </p:cNvPr>
          <p:cNvSpPr/>
          <p:nvPr/>
        </p:nvSpPr>
        <p:spPr>
          <a:xfrm>
            <a:off x="5905403" y="5665649"/>
            <a:ext cx="1434389" cy="742873"/>
          </a:xfrm>
          <a:prstGeom prst="parallelogram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9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Communicate Findings</a:t>
            </a:r>
          </a:p>
        </p:txBody>
      </p:sp>
      <p:sp>
        <p:nvSpPr>
          <p:cNvPr id="167" name="Flowchart: Document 166">
            <a:extLst>
              <a:ext uri="{FF2B5EF4-FFF2-40B4-BE49-F238E27FC236}">
                <a16:creationId xmlns:a16="http://schemas.microsoft.com/office/drawing/2014/main" id="{877705AE-1A4C-4EC4-EC05-BB62135314F2}"/>
              </a:ext>
            </a:extLst>
          </p:cNvPr>
          <p:cNvSpPr/>
          <p:nvPr/>
        </p:nvSpPr>
        <p:spPr>
          <a:xfrm>
            <a:off x="3927635" y="5665649"/>
            <a:ext cx="1227909" cy="986526"/>
          </a:xfrm>
          <a:prstGeom prst="flowChartDocumen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8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Develop CAPA Report</a:t>
            </a:r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A89AB435-1ECE-C589-CE4B-8C89BDDC4852}"/>
              </a:ext>
            </a:extLst>
          </p:cNvPr>
          <p:cNvSpPr/>
          <p:nvPr/>
        </p:nvSpPr>
        <p:spPr>
          <a:xfrm>
            <a:off x="2177705" y="7303394"/>
            <a:ext cx="904163" cy="445055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Go to Step 9</a:t>
            </a:r>
          </a:p>
        </p:txBody>
      </p:sp>
      <p:cxnSp>
        <p:nvCxnSpPr>
          <p:cNvPr id="170" name="Straight Arrow Connector 169">
            <a:extLst>
              <a:ext uri="{FF2B5EF4-FFF2-40B4-BE49-F238E27FC236}">
                <a16:creationId xmlns:a16="http://schemas.microsoft.com/office/drawing/2014/main" id="{95561660-A653-9D89-93EB-13EEE4E57CAD}"/>
              </a:ext>
            </a:extLst>
          </p:cNvPr>
          <p:cNvCxnSpPr>
            <a:cxnSpLocks/>
            <a:endCxn id="169" idx="1"/>
          </p:cNvCxnSpPr>
          <p:nvPr/>
        </p:nvCxnSpPr>
        <p:spPr>
          <a:xfrm>
            <a:off x="1620493" y="7525922"/>
            <a:ext cx="55721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9" name="Straight Arrow Connector 188">
            <a:extLst>
              <a:ext uri="{FF2B5EF4-FFF2-40B4-BE49-F238E27FC236}">
                <a16:creationId xmlns:a16="http://schemas.microsoft.com/office/drawing/2014/main" id="{A63882B4-E4DC-77BC-07CD-FAFB45D971CA}"/>
              </a:ext>
            </a:extLst>
          </p:cNvPr>
          <p:cNvCxnSpPr>
            <a:cxnSpLocks/>
          </p:cNvCxnSpPr>
          <p:nvPr/>
        </p:nvCxnSpPr>
        <p:spPr>
          <a:xfrm>
            <a:off x="6622597" y="6427725"/>
            <a:ext cx="1" cy="39834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1" name="Straight Arrow Connector 190">
            <a:extLst>
              <a:ext uri="{FF2B5EF4-FFF2-40B4-BE49-F238E27FC236}">
                <a16:creationId xmlns:a16="http://schemas.microsoft.com/office/drawing/2014/main" id="{BCECF2AA-07A7-645E-8E66-21E83619D04B}"/>
              </a:ext>
            </a:extLst>
          </p:cNvPr>
          <p:cNvCxnSpPr>
            <a:cxnSpLocks/>
          </p:cNvCxnSpPr>
          <p:nvPr/>
        </p:nvCxnSpPr>
        <p:spPr>
          <a:xfrm>
            <a:off x="6609367" y="8673677"/>
            <a:ext cx="0" cy="62024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5" name="Straight Arrow Connector 194">
            <a:extLst>
              <a:ext uri="{FF2B5EF4-FFF2-40B4-BE49-F238E27FC236}">
                <a16:creationId xmlns:a16="http://schemas.microsoft.com/office/drawing/2014/main" id="{F2A447CF-FD87-ABCA-079A-9B73787BF8C1}"/>
              </a:ext>
            </a:extLst>
          </p:cNvPr>
          <p:cNvCxnSpPr>
            <a:cxnSpLocks/>
          </p:cNvCxnSpPr>
          <p:nvPr/>
        </p:nvCxnSpPr>
        <p:spPr>
          <a:xfrm>
            <a:off x="3408599" y="6118428"/>
            <a:ext cx="51903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BE56C444-CBBB-197E-FFE4-566E9AF3977D}"/>
              </a:ext>
            </a:extLst>
          </p:cNvPr>
          <p:cNvCxnSpPr>
            <a:cxnSpLocks/>
            <a:stCxn id="13" idx="3"/>
          </p:cNvCxnSpPr>
          <p:nvPr/>
        </p:nvCxnSpPr>
        <p:spPr>
          <a:xfrm flipV="1">
            <a:off x="3558173" y="2055928"/>
            <a:ext cx="374508" cy="2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F00342B0-F987-FC6A-29DE-6F881E6B1623}"/>
              </a:ext>
            </a:extLst>
          </p:cNvPr>
          <p:cNvSpPr/>
          <p:nvPr/>
        </p:nvSpPr>
        <p:spPr>
          <a:xfrm>
            <a:off x="3931310" y="1630788"/>
            <a:ext cx="1227909" cy="850789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3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Conduct Initial Analysi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A5361CD-9341-0C29-4CAA-B89362DDF75A}"/>
              </a:ext>
            </a:extLst>
          </p:cNvPr>
          <p:cNvSpPr txBox="1"/>
          <p:nvPr/>
        </p:nvSpPr>
        <p:spPr>
          <a:xfrm>
            <a:off x="6058807" y="2914707"/>
            <a:ext cx="1410789" cy="338554"/>
          </a:xfrm>
          <a:prstGeom prst="rect">
            <a:avLst/>
          </a:prstGeom>
          <a:solidFill>
            <a:schemeClr val="bg1"/>
          </a:solidFill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1100" b="1" i="1" dirty="0"/>
              <a:t>Investigation required?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072B163-C343-F479-11B3-20D7A967B200}"/>
              </a:ext>
            </a:extLst>
          </p:cNvPr>
          <p:cNvSpPr txBox="1"/>
          <p:nvPr/>
        </p:nvSpPr>
        <p:spPr>
          <a:xfrm>
            <a:off x="6622598" y="4320969"/>
            <a:ext cx="238431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/>
              <a:t>No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0A2E38FC-8F3D-D06A-3ADE-CEAEAFC8F515}"/>
              </a:ext>
            </a:extLst>
          </p:cNvPr>
          <p:cNvCxnSpPr>
            <a:cxnSpLocks/>
          </p:cNvCxnSpPr>
          <p:nvPr/>
        </p:nvCxnSpPr>
        <p:spPr>
          <a:xfrm flipH="1">
            <a:off x="3408599" y="3867385"/>
            <a:ext cx="522710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BF2A4347-05ED-4596-AB59-FDA7AE84A45E}"/>
              </a:ext>
            </a:extLst>
          </p:cNvPr>
          <p:cNvSpPr txBox="1"/>
          <p:nvPr/>
        </p:nvSpPr>
        <p:spPr>
          <a:xfrm>
            <a:off x="539388" y="4852481"/>
            <a:ext cx="992767" cy="430887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ctr"/>
            <a:r>
              <a:rPr lang="en-US" sz="1100" b="1" i="1" dirty="0"/>
              <a:t>Formal CAPA* Required?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8BB99208-8573-A7BA-A354-9E8CC7E6766F}"/>
              </a:ext>
            </a:extLst>
          </p:cNvPr>
          <p:cNvCxnSpPr>
            <a:cxnSpLocks/>
            <a:stCxn id="4" idx="1"/>
            <a:endCxn id="25" idx="3"/>
          </p:cNvCxnSpPr>
          <p:nvPr/>
        </p:nvCxnSpPr>
        <p:spPr>
          <a:xfrm flipH="1">
            <a:off x="5159218" y="3865946"/>
            <a:ext cx="1295931" cy="613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9AC57011-5297-B432-85C9-3C50B8623F80}"/>
              </a:ext>
            </a:extLst>
          </p:cNvPr>
          <p:cNvSpPr txBox="1"/>
          <p:nvPr/>
        </p:nvSpPr>
        <p:spPr>
          <a:xfrm>
            <a:off x="5670137" y="3735141"/>
            <a:ext cx="286892" cy="261610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ctr"/>
            <a:r>
              <a:rPr lang="en-US" sz="1100" dirty="0"/>
              <a:t>Yes</a:t>
            </a: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644148E5-C0E5-AACF-D0B8-9417FE1912D8}"/>
              </a:ext>
            </a:extLst>
          </p:cNvPr>
          <p:cNvCxnSpPr>
            <a:cxnSpLocks/>
          </p:cNvCxnSpPr>
          <p:nvPr/>
        </p:nvCxnSpPr>
        <p:spPr>
          <a:xfrm>
            <a:off x="5155544" y="6091043"/>
            <a:ext cx="80148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566BF526-5270-7E17-394E-FCB6E15FA30A}"/>
              </a:ext>
            </a:extLst>
          </p:cNvPr>
          <p:cNvSpPr/>
          <p:nvPr/>
        </p:nvSpPr>
        <p:spPr>
          <a:xfrm flipH="1">
            <a:off x="-1" y="595"/>
            <a:ext cx="7772400" cy="271961"/>
          </a:xfrm>
          <a:prstGeom prst="rect">
            <a:avLst/>
          </a:prstGeom>
          <a:gradFill flip="none" rotWithShape="1">
            <a:gsLst>
              <a:gs pos="2000">
                <a:srgbClr val="027CBA"/>
              </a:gs>
              <a:gs pos="94000">
                <a:schemeClr val="accent1">
                  <a:lumMod val="5000"/>
                  <a:lumOff val="95000"/>
                </a:schemeClr>
              </a:gs>
            </a:gsLst>
            <a:lin ang="10800000" scaled="0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/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b="1" kern="120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emplate Example</a:t>
            </a:r>
            <a:endParaRPr lang="en-US" sz="10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8DFA155D-324A-6AF1-D349-965C407DFE06}"/>
              </a:ext>
            </a:extLst>
          </p:cNvPr>
          <p:cNvSpPr/>
          <p:nvPr/>
        </p:nvSpPr>
        <p:spPr>
          <a:xfrm>
            <a:off x="5905404" y="7980612"/>
            <a:ext cx="1410788" cy="764457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11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Evaluate Effectiveness of Actions Taken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468C2AB9-A90D-1AA7-8273-191F5E1CE7FA}"/>
              </a:ext>
            </a:extLst>
          </p:cNvPr>
          <p:cNvCxnSpPr>
            <a:cxnSpLocks/>
          </p:cNvCxnSpPr>
          <p:nvPr/>
        </p:nvCxnSpPr>
        <p:spPr>
          <a:xfrm>
            <a:off x="6634494" y="7584334"/>
            <a:ext cx="1" cy="39834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078796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TextBox 162">
            <a:extLst>
              <a:ext uri="{FF2B5EF4-FFF2-40B4-BE49-F238E27FC236}">
                <a16:creationId xmlns:a16="http://schemas.microsoft.com/office/drawing/2014/main" id="{F519353C-ACB2-009D-71DD-DA957017DA1D}"/>
              </a:ext>
            </a:extLst>
          </p:cNvPr>
          <p:cNvSpPr txBox="1"/>
          <p:nvPr/>
        </p:nvSpPr>
        <p:spPr>
          <a:xfrm>
            <a:off x="541338" y="974337"/>
            <a:ext cx="38862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ysClr val="windowText" lastClr="000000"/>
                </a:solidFill>
              </a:rPr>
              <a:t>Legend</a:t>
            </a:r>
            <a:endParaRPr lang="en-US" sz="1200" b="1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66BF526-5270-7E17-394E-FCB6E15FA30A}"/>
              </a:ext>
            </a:extLst>
          </p:cNvPr>
          <p:cNvSpPr/>
          <p:nvPr/>
        </p:nvSpPr>
        <p:spPr>
          <a:xfrm flipH="1">
            <a:off x="-1" y="595"/>
            <a:ext cx="7772400" cy="271961"/>
          </a:xfrm>
          <a:prstGeom prst="rect">
            <a:avLst/>
          </a:prstGeom>
          <a:gradFill flip="none" rotWithShape="1">
            <a:gsLst>
              <a:gs pos="2000">
                <a:srgbClr val="027CBA"/>
              </a:gs>
              <a:gs pos="94000">
                <a:schemeClr val="accent1">
                  <a:lumMod val="5000"/>
                  <a:lumOff val="95000"/>
                </a:schemeClr>
              </a:gs>
            </a:gsLst>
            <a:lin ang="10800000" scaled="0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/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b="1" kern="120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emplate Example</a:t>
            </a:r>
            <a:endParaRPr lang="en-US" sz="10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aphicFrame>
        <p:nvGraphicFramePr>
          <p:cNvPr id="49" name="Table 48">
            <a:extLst>
              <a:ext uri="{FF2B5EF4-FFF2-40B4-BE49-F238E27FC236}">
                <a16:creationId xmlns:a16="http://schemas.microsoft.com/office/drawing/2014/main" id="{92574808-9FEA-7B0C-99AD-35689BA224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2841111"/>
              </p:ext>
            </p:extLst>
          </p:nvPr>
        </p:nvGraphicFramePr>
        <p:xfrm>
          <a:off x="541338" y="1811336"/>
          <a:ext cx="6702425" cy="2822575"/>
        </p:xfrm>
        <a:graphic>
          <a:graphicData uri="http://schemas.openxmlformats.org/drawingml/2006/table">
            <a:tbl>
              <a:tblPr firstRow="1" firstCol="1" bandRow="1"/>
              <a:tblGrid>
                <a:gridCol w="2233248">
                  <a:extLst>
                    <a:ext uri="{9D8B030D-6E8A-4147-A177-3AD203B41FA5}">
                      <a16:colId xmlns:a16="http://schemas.microsoft.com/office/drawing/2014/main" val="3602462692"/>
                    </a:ext>
                  </a:extLst>
                </a:gridCol>
                <a:gridCol w="2068368">
                  <a:extLst>
                    <a:ext uri="{9D8B030D-6E8A-4147-A177-3AD203B41FA5}">
                      <a16:colId xmlns:a16="http://schemas.microsoft.com/office/drawing/2014/main" val="286214952"/>
                    </a:ext>
                  </a:extLst>
                </a:gridCol>
                <a:gridCol w="2400809">
                  <a:extLst>
                    <a:ext uri="{9D8B030D-6E8A-4147-A177-3AD203B41FA5}">
                      <a16:colId xmlns:a16="http://schemas.microsoft.com/office/drawing/2014/main" val="253329001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ymbo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unctio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14357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cess / Actio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presents a process or action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80923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rrow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hows relationships between the representative shapes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93736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amond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ymbolizes that a decision needs to be made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8474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ocumen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presents the input or output of a document, specificall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69152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put / Outpu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presents data that is available for input or output as well as representing resources used or generated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1610861"/>
                  </a:ext>
                </a:extLst>
              </a:tr>
            </a:tbl>
          </a:graphicData>
        </a:graphic>
      </p:graphicFrame>
      <p:sp>
        <p:nvSpPr>
          <p:cNvPr id="51" name="Rectangle 50">
            <a:extLst>
              <a:ext uri="{FF2B5EF4-FFF2-40B4-BE49-F238E27FC236}">
                <a16:creationId xmlns:a16="http://schemas.microsoft.com/office/drawing/2014/main" id="{4D54160F-852C-6A4B-ED2B-C29AFF46AE97}"/>
              </a:ext>
            </a:extLst>
          </p:cNvPr>
          <p:cNvSpPr/>
          <p:nvPr/>
        </p:nvSpPr>
        <p:spPr>
          <a:xfrm>
            <a:off x="1265238" y="2024555"/>
            <a:ext cx="812800" cy="4254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/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1307070F-5E23-D418-7ADD-FDC9A71C1A8D}"/>
              </a:ext>
            </a:extLst>
          </p:cNvPr>
          <p:cNvCxnSpPr/>
          <p:nvPr/>
        </p:nvCxnSpPr>
        <p:spPr>
          <a:xfrm>
            <a:off x="1169988" y="2765918"/>
            <a:ext cx="94615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Flowchart: Decision 54">
            <a:extLst>
              <a:ext uri="{FF2B5EF4-FFF2-40B4-BE49-F238E27FC236}">
                <a16:creationId xmlns:a16="http://schemas.microsoft.com/office/drawing/2014/main" id="{C4D6F9AD-6574-2B40-76CB-7E7BEB1AC837}"/>
              </a:ext>
            </a:extLst>
          </p:cNvPr>
          <p:cNvSpPr/>
          <p:nvPr/>
        </p:nvSpPr>
        <p:spPr>
          <a:xfrm>
            <a:off x="1406525" y="3054843"/>
            <a:ext cx="520700" cy="457200"/>
          </a:xfrm>
          <a:prstGeom prst="flowChartDecision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/>
          </a:p>
        </p:txBody>
      </p:sp>
      <p:sp>
        <p:nvSpPr>
          <p:cNvPr id="56" name="Flowchart: Document 55">
            <a:extLst>
              <a:ext uri="{FF2B5EF4-FFF2-40B4-BE49-F238E27FC236}">
                <a16:creationId xmlns:a16="http://schemas.microsoft.com/office/drawing/2014/main" id="{0292F8EC-02F0-61A2-2C5C-13DDF1F867AC}"/>
              </a:ext>
            </a:extLst>
          </p:cNvPr>
          <p:cNvSpPr/>
          <p:nvPr/>
        </p:nvSpPr>
        <p:spPr>
          <a:xfrm>
            <a:off x="1417638" y="3602909"/>
            <a:ext cx="520700" cy="450850"/>
          </a:xfrm>
          <a:prstGeom prst="flowChartDocumen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/>
          </a:p>
        </p:txBody>
      </p:sp>
      <p:sp>
        <p:nvSpPr>
          <p:cNvPr id="58" name="Flowchart: Data 57">
            <a:extLst>
              <a:ext uri="{FF2B5EF4-FFF2-40B4-BE49-F238E27FC236}">
                <a16:creationId xmlns:a16="http://schemas.microsoft.com/office/drawing/2014/main" id="{C41B943D-216D-57B3-46ED-519B4AA03D0A}"/>
              </a:ext>
            </a:extLst>
          </p:cNvPr>
          <p:cNvSpPr/>
          <p:nvPr/>
        </p:nvSpPr>
        <p:spPr>
          <a:xfrm>
            <a:off x="1190625" y="4189421"/>
            <a:ext cx="904875" cy="371475"/>
          </a:xfrm>
          <a:prstGeom prst="flowChartInputOutpu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61459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D24004269783F4484DD1848A00DFD3B" ma:contentTypeVersion="14" ma:contentTypeDescription="Create a new document." ma:contentTypeScope="" ma:versionID="949d91f85b0396c07df2e601f29e3eab">
  <xsd:schema xmlns:xsd="http://www.w3.org/2001/XMLSchema" xmlns:xs="http://www.w3.org/2001/XMLSchema" xmlns:p="http://schemas.microsoft.com/office/2006/metadata/properties" xmlns:ns2="bc6fc9a0-8cf0-435b-a5c3-787b2fe5bedd" xmlns:ns3="20867c8d-1cc9-4acd-a073-94634f6a764f" targetNamespace="http://schemas.microsoft.com/office/2006/metadata/properties" ma:root="true" ma:fieldsID="9dc925c5a342fbd71a3badc790b9c820" ns2:_="" ns3:_="">
    <xsd:import namespace="bc6fc9a0-8cf0-435b-a5c3-787b2fe5bedd"/>
    <xsd:import namespace="20867c8d-1cc9-4acd-a073-94634f6a764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SearchProperties" minOccurs="0"/>
                <xsd:element ref="ns2:MediaLengthInSecond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c6fc9a0-8cf0-435b-a5c3-787b2fe5bed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79cf906e-e933-44a8-8421-1c91ada6f122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9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1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0867c8d-1cc9-4acd-a073-94634f6a764f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bf2d2cf4-37d0-44af-aad9-3d314cc6947a}" ma:internalName="TaxCatchAll" ma:showField="CatchAllData" ma:web="7467b07a-63e4-4526-818f-48c6a4d2dc7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0867c8d-1cc9-4acd-a073-94634f6a764f" xsi:nil="true"/>
    <lcf76f155ced4ddcb4097134ff3c332f xmlns="bc6fc9a0-8cf0-435b-a5c3-787b2fe5bedd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5A6F0437-CEDA-4923-B330-277950407B3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c6fc9a0-8cf0-435b-a5c3-787b2fe5bedd"/>
    <ds:schemaRef ds:uri="20867c8d-1cc9-4acd-a073-94634f6a764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EADA044-D78F-45A6-A637-B9591E96BA6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028C082-5252-4DB6-A2C5-44EE28293CB6}">
  <ds:schemaRefs>
    <ds:schemaRef ds:uri="http://schemas.microsoft.com/office/2006/metadata/properties"/>
    <ds:schemaRef ds:uri="http://schemas.microsoft.com/office/infopath/2007/PartnerControls"/>
    <ds:schemaRef ds:uri="20867c8d-1cc9-4acd-a073-94634f6a764f"/>
    <ds:schemaRef ds:uri="bc6fc9a0-8cf0-435b-a5c3-787b2fe5bedd"/>
  </ds:schemaRefs>
</ds:datastoreItem>
</file>

<file path=docMetadata/LabelInfo.xml><?xml version="1.0" encoding="utf-8"?>
<clbl:labelList xmlns:clbl="http://schemas.microsoft.com/office/2020/mipLabelMetadata">
  <clbl:label id="{7d2fdb41-339c-4257-87f2-a665730b31fc}" enabled="0" method="" siteId="{7d2fdb41-339c-4257-87f2-a665730b31fc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9</TotalTime>
  <Words>178</Words>
  <Application>Microsoft Office PowerPoint</Application>
  <PresentationFormat>Custom</PresentationFormat>
  <Paragraphs>6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Fox, Elizabeth</cp:lastModifiedBy>
  <cp:revision>1</cp:revision>
  <dcterms:created xsi:type="dcterms:W3CDTF">2025-03-18T14:31:12Z</dcterms:created>
  <dcterms:modified xsi:type="dcterms:W3CDTF">2025-03-19T15:34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D24004269783F4484DD1848A00DFD3B</vt:lpwstr>
  </property>
  <property fmtid="{D5CDD505-2E9C-101B-9397-08002B2CF9AE}" pid="3" name="MediaServiceImageTags">
    <vt:lpwstr/>
  </property>
</Properties>
</file>